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A0F"/>
    <a:srgbClr val="FF9966"/>
    <a:srgbClr val="FF00FF"/>
    <a:srgbClr val="00C060"/>
    <a:srgbClr val="00CC66"/>
    <a:srgbClr val="000000"/>
    <a:srgbClr val="00D214"/>
    <a:srgbClr val="EAAD00"/>
    <a:srgbClr val="33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09" autoAdjust="0"/>
    <p:restoredTop sz="93664" autoAdjust="0"/>
  </p:normalViewPr>
  <p:slideViewPr>
    <p:cSldViewPr>
      <p:cViewPr varScale="1">
        <p:scale>
          <a:sx n="115" d="100"/>
          <a:sy n="115" d="100"/>
        </p:scale>
        <p:origin x="834" y="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EC58E5-5735-4585-BC59-F9C6D2BB7655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328C6-9676-439A-871C-660F99C69C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96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3295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014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5820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501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54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7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346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8399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645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7230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75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691BF-6F55-4D8A-9717-19385ADCFADD}" type="datetimeFigureOut">
              <a:rPr lang="ko-KR" altLang="en-US" smtClean="0"/>
              <a:t>2016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669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4"/>
          <p:cNvSpPr txBox="1">
            <a:spLocks noChangeArrowheads="1"/>
          </p:cNvSpPr>
          <p:nvPr/>
        </p:nvSpPr>
        <p:spPr bwMode="auto">
          <a:xfrm>
            <a:off x="260350" y="6796697"/>
            <a:ext cx="6048375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r>
              <a:rPr kumimoji="0" lang="en-US" altLang="ko-KR" sz="1200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r>
              <a:rPr kumimoji="0" lang="ko-KR" alt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ko-KR" sz="1200" b="1" dirty="0" smtClean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tereoview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of i</a:t>
            </a:r>
            <a:r>
              <a:rPr kumimoji="0" lang="en-US" altLang="ko-KR" sz="1200" dirty="0" smtClean="0">
                <a:latin typeface="Times New Roman" pitchFamily="18" charset="0"/>
                <a:cs typeface="Times New Roman" pitchFamily="18" charset="0"/>
              </a:rPr>
              <a:t>nvolvement of V146 in the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ubstrate binding. The AS-loop and PS-loop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in the 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Sr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LDC</a:t>
            </a:r>
            <a:r>
              <a:rPr lang="en-US" altLang="ko-KR" sz="1200" baseline="30000" dirty="0">
                <a:latin typeface="Times New Roman" pitchFamily="18" charset="0"/>
                <a:cs typeface="Times New Roman" pitchFamily="18" charset="0"/>
              </a:rPr>
              <a:t>A225C/T302C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mutant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are colored green and salmon, respectively. The residues involved in the substrate binding are shown as a stick model and labeled and Val146 is distinguished with green color. The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cadaverin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molecule and the PLP cofactor are shown as stick models with yellow and salmon colors, respectively. 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63" b="9819"/>
          <a:stretch/>
        </p:blipFill>
        <p:spPr>
          <a:xfrm>
            <a:off x="81644" y="2483768"/>
            <a:ext cx="6694713" cy="2952328"/>
          </a:xfrm>
          <a:prstGeom prst="rect">
            <a:avLst/>
          </a:prstGeom>
        </p:spPr>
      </p:pic>
      <p:grpSp>
        <p:nvGrpSpPr>
          <p:cNvPr id="7" name="그룹 6"/>
          <p:cNvGrpSpPr/>
          <p:nvPr/>
        </p:nvGrpSpPr>
        <p:grpSpPr>
          <a:xfrm>
            <a:off x="452143" y="2897218"/>
            <a:ext cx="6108826" cy="1957726"/>
            <a:chOff x="452164" y="2897218"/>
            <a:chExt cx="6108826" cy="1957726"/>
          </a:xfrm>
        </p:grpSpPr>
        <p:grpSp>
          <p:nvGrpSpPr>
            <p:cNvPr id="5" name="그룹 4"/>
            <p:cNvGrpSpPr/>
            <p:nvPr/>
          </p:nvGrpSpPr>
          <p:grpSpPr>
            <a:xfrm>
              <a:off x="452164" y="2897218"/>
              <a:ext cx="2778990" cy="1957726"/>
              <a:chOff x="452164" y="2900359"/>
              <a:chExt cx="2778990" cy="1957726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607613" y="3385228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V146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328893" y="3552847"/>
                <a:ext cx="91242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Cadaverine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52164" y="3022211"/>
                <a:ext cx="44595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PLP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409162" y="4604169"/>
                <a:ext cx="50847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D299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132856" y="4082345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Y298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730696" y="3934503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S356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669343" y="3000287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Y290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910384" y="2900359"/>
                <a:ext cx="49244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F360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996012" y="4061466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Y352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218484" y="3034431"/>
                <a:ext cx="50847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D324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4" name="그룹 23"/>
            <p:cNvGrpSpPr/>
            <p:nvPr/>
          </p:nvGrpSpPr>
          <p:grpSpPr>
            <a:xfrm>
              <a:off x="3782000" y="2897218"/>
              <a:ext cx="2778990" cy="1957726"/>
              <a:chOff x="452164" y="2900359"/>
              <a:chExt cx="2778990" cy="1957726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607613" y="3385228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V146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328893" y="3552847"/>
                <a:ext cx="91242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Cadaverine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452164" y="3022211"/>
                <a:ext cx="44595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PLP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409162" y="4604169"/>
                <a:ext cx="50847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D299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132856" y="4082345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Y298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730696" y="3934503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S356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669343" y="3000287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Y290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910384" y="2900359"/>
                <a:ext cx="49244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F360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996012" y="4061466"/>
                <a:ext cx="50045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Y352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218484" y="3034431"/>
                <a:ext cx="50847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b="1" dirty="0" smtClean="0">
                    <a:latin typeface="Arial" pitchFamily="34" charset="0"/>
                    <a:cs typeface="Arial" pitchFamily="34" charset="0"/>
                  </a:rPr>
                  <a:t>D324</a:t>
                </a:r>
                <a:endParaRPr lang="ko-KR" altLang="en-US" sz="105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60952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45</TotalTime>
  <Words>92</Words>
  <Application>Microsoft Office PowerPoint</Application>
  <PresentationFormat>화면 슬라이드 쇼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448</cp:revision>
  <cp:lastPrinted>2016-01-23T05:51:27Z</cp:lastPrinted>
  <dcterms:created xsi:type="dcterms:W3CDTF">2015-12-21T06:27:49Z</dcterms:created>
  <dcterms:modified xsi:type="dcterms:W3CDTF">2016-12-30T00:59:22Z</dcterms:modified>
</cp:coreProperties>
</file>